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91" userDrawn="1">
          <p15:clr>
            <a:srgbClr val="A4A3A4"/>
          </p15:clr>
        </p15:guide>
        <p15:guide id="2" pos="28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53"/>
    <p:restoredTop sz="94643"/>
  </p:normalViewPr>
  <p:slideViewPr>
    <p:cSldViewPr snapToGrid="0" snapToObjects="1" showGuides="1">
      <p:cViewPr>
        <p:scale>
          <a:sx n="116" d="100"/>
          <a:sy n="116" d="100"/>
        </p:scale>
        <p:origin x="1408" y="168"/>
      </p:cViewPr>
      <p:guideLst>
        <p:guide orient="horz" pos="2591"/>
        <p:guide pos="288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iolmac103%20HD:Users:erdelyip:Work:Projects:let-418%20suppression%20screen:Comparisons:daf-16:let418%20L1%20RNAseq%20vs%20daf16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>
        <c:manualLayout>
          <c:layoutTarget val="inner"/>
          <c:xMode val="edge"/>
          <c:yMode val="edge"/>
          <c:x val="0.454689867452273"/>
          <c:y val="0.0604170570050119"/>
          <c:w val="0.516731804960413"/>
          <c:h val="0.798548087732446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RNAseq comp'!$X$21:$X$33</c:f>
              <c:strCache>
                <c:ptCount val="13"/>
                <c:pt idx="0">
                  <c:v>ion homeostasis (p=9.40E-02)</c:v>
                </c:pt>
                <c:pt idx="1">
                  <c:v>fatty acid beta-oxidation (p=1.40E-02)</c:v>
                </c:pt>
                <c:pt idx="2">
                  <c:v>carboxylic acid catabolic process (p=2.80E-02)</c:v>
                </c:pt>
                <c:pt idx="3">
                  <c:v>fatty acid biosynthetic process (p=1.10E-02)</c:v>
                </c:pt>
                <c:pt idx="4">
                  <c:v>sodium ion transport (p=2.50E-02)</c:v>
                </c:pt>
                <c:pt idx="5">
                  <c:v>lipid modification (p=4.90E-03)</c:v>
                </c:pt>
                <c:pt idx="6">
                  <c:v>fatty acid metabolic process (p=2.10E-04)</c:v>
                </c:pt>
                <c:pt idx="7">
                  <c:v>metal ion transport (p=6.70E-02)</c:v>
                </c:pt>
                <c:pt idx="8">
                  <c:v>monovalent inorganic cation transport (p=5.80E-02)</c:v>
                </c:pt>
                <c:pt idx="9">
                  <c:v>aging (p=1.80E-03)</c:v>
                </c:pt>
                <c:pt idx="10">
                  <c:v>ion transport (p=6.30E-02)</c:v>
                </c:pt>
                <c:pt idx="11">
                  <c:v>proteolysis (p=3.00E-02)</c:v>
                </c:pt>
                <c:pt idx="12">
                  <c:v>oxidation reduction (p=2.20E-05)</c:v>
                </c:pt>
              </c:strCache>
            </c:strRef>
          </c:cat>
          <c:val>
            <c:numRef>
              <c:f>'RNAseq comp'!$Y$21:$Y$33</c:f>
              <c:numCache>
                <c:formatCode>General</c:formatCode>
                <c:ptCount val="13"/>
                <c:pt idx="0">
                  <c:v>0.8</c:v>
                </c:pt>
                <c:pt idx="1">
                  <c:v>0.8</c:v>
                </c:pt>
                <c:pt idx="2">
                  <c:v>1.1</c:v>
                </c:pt>
                <c:pt idx="3">
                  <c:v>1.1</c:v>
                </c:pt>
                <c:pt idx="4">
                  <c:v>1.4</c:v>
                </c:pt>
                <c:pt idx="5">
                  <c:v>1.6</c:v>
                </c:pt>
                <c:pt idx="6">
                  <c:v>1.9</c:v>
                </c:pt>
                <c:pt idx="7">
                  <c:v>2.5</c:v>
                </c:pt>
                <c:pt idx="8">
                  <c:v>2.5</c:v>
                </c:pt>
                <c:pt idx="9">
                  <c:v>3.6</c:v>
                </c:pt>
                <c:pt idx="10">
                  <c:v>4.1</c:v>
                </c:pt>
                <c:pt idx="11">
                  <c:v>4.7</c:v>
                </c:pt>
                <c:pt idx="12">
                  <c:v>5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8463920"/>
        <c:axId val="-1997991136"/>
      </c:barChart>
      <c:catAx>
        <c:axId val="178846392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en-US"/>
          </a:p>
        </c:txPr>
        <c:crossAx val="-1997991136"/>
        <c:crosses val="autoZero"/>
        <c:auto val="1"/>
        <c:lblAlgn val="ctr"/>
        <c:lblOffset val="100"/>
        <c:noMultiLvlLbl val="0"/>
      </c:catAx>
      <c:valAx>
        <c:axId val="-1997991136"/>
        <c:scaling>
          <c:orientation val="minMax"/>
        </c:scaling>
        <c:delete val="0"/>
        <c:axPos val="b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% gene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884639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31"/>
            <a:ext cx="7772401" cy="1470025"/>
          </a:xfrm>
        </p:spPr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u-H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64197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12859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31248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810791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9"/>
            <a:ext cx="77724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95057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2" y="1600206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88362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7" y="1535113"/>
            <a:ext cx="40401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7" y="2174875"/>
            <a:ext cx="40401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2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2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774888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92546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755621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273051"/>
            <a:ext cx="300831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1435100"/>
            <a:ext cx="300831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13229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u-H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33724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3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600206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Click to edit Master text styles</a:t>
            </a:r>
          </a:p>
          <a:p>
            <a:pPr lvl="1"/>
            <a:r>
              <a:rPr lang="hu-HU" smtClean="0"/>
              <a:t>Second level</a:t>
            </a:r>
          </a:p>
          <a:p>
            <a:pPr lvl="2"/>
            <a:r>
              <a:rPr lang="hu-HU" smtClean="0"/>
              <a:t>Third level</a:t>
            </a:r>
          </a:p>
          <a:p>
            <a:pPr lvl="3"/>
            <a:r>
              <a:rPr lang="hu-HU" smtClean="0"/>
              <a:t>Fourth level</a:t>
            </a:r>
          </a:p>
          <a:p>
            <a:pPr lvl="4"/>
            <a:r>
              <a:rPr lang="hu-H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892B83-9CEB-5344-B5FF-084C125A621D}" type="datetimeFigureOut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12/21/16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3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1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53453-19ED-9640-8F98-6E8E7A998BA6}" type="slidenum">
              <a:rPr lang="en-US" smtClean="0">
                <a:solidFill>
                  <a:prstClr val="black">
                    <a:tint val="75000"/>
                  </a:prstClr>
                </a:solidFill>
                <a:latin typeface="Calibri"/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  <a:latin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533599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/>
          <p:cNvSpPr/>
          <p:nvPr/>
        </p:nvSpPr>
        <p:spPr>
          <a:xfrm>
            <a:off x="3312543" y="1509451"/>
            <a:ext cx="1135851" cy="1135851"/>
          </a:xfrm>
          <a:prstGeom prst="ellipse">
            <a:avLst/>
          </a:prstGeom>
          <a:solidFill>
            <a:srgbClr val="008000">
              <a:alpha val="50000"/>
            </a:srgbClr>
          </a:solidFill>
          <a:ln w="38100">
            <a:solidFill>
              <a:srgbClr val="008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8000"/>
              </a:solidFill>
            </a:endParaRPr>
          </a:p>
        </p:txBody>
      </p:sp>
      <p:sp>
        <p:nvSpPr>
          <p:cNvPr id="3" name="Oval 2"/>
          <p:cNvSpPr/>
          <p:nvPr/>
        </p:nvSpPr>
        <p:spPr>
          <a:xfrm>
            <a:off x="2268615" y="1390457"/>
            <a:ext cx="1363018" cy="1363018"/>
          </a:xfrm>
          <a:prstGeom prst="ellipse">
            <a:avLst/>
          </a:prstGeom>
          <a:solidFill>
            <a:srgbClr val="3366FF">
              <a:alpha val="50000"/>
            </a:srgbClr>
          </a:solidFill>
          <a:ln w="38100"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 w="12700" cmpd="sng">
                <a:solidFill>
                  <a:schemeClr val="tx1"/>
                </a:solidFill>
              </a:ln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031508" y="1354819"/>
            <a:ext cx="5859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/>
              <a:t>let-418</a:t>
            </a:r>
            <a:endParaRPr lang="en-US" sz="1000" i="1" dirty="0"/>
          </a:p>
        </p:txBody>
      </p:sp>
      <p:sp>
        <p:nvSpPr>
          <p:cNvPr id="5" name="TextBox 4"/>
          <p:cNvSpPr txBox="1"/>
          <p:nvPr/>
        </p:nvSpPr>
        <p:spPr>
          <a:xfrm>
            <a:off x="4028500" y="1869165"/>
            <a:ext cx="44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1547</a:t>
            </a:r>
            <a:endParaRPr lang="en-US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3275293" y="1869165"/>
            <a:ext cx="5712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36</a:t>
            </a:r>
            <a:r>
              <a:rPr lang="en-US" sz="1000" dirty="0"/>
              <a:t>4</a:t>
            </a:r>
            <a:r>
              <a:rPr lang="en-US" sz="1000" dirty="0" smtClean="0"/>
              <a:t>***</a:t>
            </a:r>
            <a:endParaRPr lang="en-US" sz="1000" dirty="0"/>
          </a:p>
        </p:txBody>
      </p:sp>
      <p:sp>
        <p:nvSpPr>
          <p:cNvPr id="7" name="TextBox 6"/>
          <p:cNvSpPr txBox="1"/>
          <p:nvPr/>
        </p:nvSpPr>
        <p:spPr>
          <a:xfrm>
            <a:off x="2288804" y="1869165"/>
            <a:ext cx="44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2349</a:t>
            </a:r>
            <a:endParaRPr lang="en-US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4221393" y="1447630"/>
            <a:ext cx="5583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/>
              <a:t>daf-16</a:t>
            </a:r>
            <a:endParaRPr lang="en-US" sz="1000" i="1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43469562"/>
              </p:ext>
            </p:extLst>
          </p:nvPr>
        </p:nvGraphicFramePr>
        <p:xfrm>
          <a:off x="0" y="3250788"/>
          <a:ext cx="6338788" cy="27326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4251571" y="2702162"/>
            <a:ext cx="88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**   p≤0,001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4409" y="108412"/>
            <a:ext cx="848517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S6 : DAF-16 and LET-418 share common target genes involved in metabolic pathways. </a:t>
            </a:r>
            <a:r>
              <a:rPr lang="en-US" sz="1400" dirty="0" err="1" smtClean="0"/>
              <a:t>Transcriptome</a:t>
            </a:r>
            <a:r>
              <a:rPr lang="en-US" sz="1400" dirty="0" smtClean="0"/>
              <a:t> analysis of </a:t>
            </a:r>
            <a:r>
              <a:rPr lang="en-US" sz="1400" i="1" dirty="0" smtClean="0"/>
              <a:t>let-418</a:t>
            </a:r>
            <a:r>
              <a:rPr lang="en-US" sz="1400" dirty="0" smtClean="0"/>
              <a:t> and </a:t>
            </a:r>
            <a:r>
              <a:rPr lang="en-US" sz="1400" i="1" dirty="0" smtClean="0"/>
              <a:t>daf-16</a:t>
            </a:r>
            <a:r>
              <a:rPr lang="en-US" sz="1400" dirty="0" smtClean="0"/>
              <a:t> mutants revealed a significant overlap between the 2 sets of target genes. </a:t>
            </a:r>
            <a:r>
              <a:rPr lang="en-US" sz="1400" dirty="0"/>
              <a:t>P-values were determined by Fischer's exact test. </a:t>
            </a:r>
            <a:r>
              <a:rPr lang="en-US" sz="1400" dirty="0" smtClean="0"/>
              <a:t>(B) Go term analysis using the DAVID database indicates that common target genes are involved in various metabolic pathways.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915827" y="957845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966224" y="294838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35177928"/>
      </p:ext>
    </p:extLst>
  </p:cSld>
  <p:clrMapOvr>
    <a:masterClrMapping/>
  </p:clrMapOvr>
</p:sld>
</file>

<file path=ppt/theme/theme1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73</TotalTime>
  <Words>78</Words>
  <Application>Microsoft Macintosh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2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tal WIcky</dc:creator>
  <cp:lastModifiedBy>Microsoft Office User</cp:lastModifiedBy>
  <cp:revision>52</cp:revision>
  <cp:lastPrinted>2016-11-17T08:14:39Z</cp:lastPrinted>
  <dcterms:created xsi:type="dcterms:W3CDTF">2016-05-11T08:55:17Z</dcterms:created>
  <dcterms:modified xsi:type="dcterms:W3CDTF">2016-12-21T09:17:36Z</dcterms:modified>
</cp:coreProperties>
</file>